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9" r:id="rId2"/>
    <p:sldId id="509" r:id="rId3"/>
    <p:sldId id="531" r:id="rId4"/>
    <p:sldId id="535" r:id="rId5"/>
    <p:sldId id="53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6E78C49-4B08-191F-D7E2-2F4F1F2233A0}" name="Jonathan Angel" initials="JA" userId="S::jangel@toh.ca::8d5a57b5-997d-47e7-9f18-478d0d46181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3" autoAdjust="0"/>
    <p:restoredTop sz="94640"/>
  </p:normalViewPr>
  <p:slideViewPr>
    <p:cSldViewPr snapToGrid="0">
      <p:cViewPr varScale="1">
        <p:scale>
          <a:sx n="102" d="100"/>
          <a:sy n="102" d="100"/>
        </p:scale>
        <p:origin x="8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089C9-FF99-B1D7-A7AB-DD32DEFF7C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0DAA4E-C7E2-911A-18C0-DBA796B504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0A4EC-7FBD-D3A0-5E85-DAAA36005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B2318-7671-178F-0758-7EA30AF08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6EAFE-7768-974F-A1D0-109BCE343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5413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8F1C23-2744-3883-63D3-E187F94FD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1B0DE4-15BC-8835-7DB4-E3BF70A7BB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DBF81-A37E-8B8E-9CDA-817A599AF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1BC75E-36A4-3C01-8FB1-297117BC4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A84C17-6066-7A49-CD8D-D5AC87E8F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316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BE66B7-18CB-4B5C-A231-F8CEE0672E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1D2440-588B-8B53-537A-00B32179F3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0111AB-80F7-24F9-46B5-4225C84F2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5E15D7-5F46-3B4A-51EA-7BDB182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C1821B-C5D6-E3E8-2AF5-C505D0D1E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58976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96791F-EC01-53F4-43E2-18DDF4165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8BE33-BB1B-ED6E-B5B9-58488B320E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0A28EF-D0AF-7774-0BE0-21D91F514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953967-1C04-26AA-F08D-4D0DE10F4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C93BF-E3E3-D842-8A6B-80DABFC7B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8572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A04B4-10E2-E9A0-C199-154B58162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4553DC-250C-C049-C096-F1D85595EE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7920B-78A2-D726-6881-0EECD7553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B5291-37E9-1813-B770-C546ED082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092F85-F75B-7515-B47C-23B039CAD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603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13E5AB-50B0-2932-1B98-3C0BE38EFE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542C0C-BB0B-B270-0A4C-4FD8F8B8C6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6A2BAC-47C8-AAF0-5C8F-FA0BF8C209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A477B7-479A-6615-8AB8-C8570F7CB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77365F-822F-2ACD-08BC-E55CDD4A1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58DC8-AF4E-C268-B74C-6A0913126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3692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9AF88-42C2-2AD5-E897-17A1D0CF1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BCEABF-65B4-970A-BCA5-D6C1D5AFA9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6A09EE-19FC-C8B8-36CC-B9BDEBDFD6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0EF7B6-7868-3381-C1D2-A56F889C21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309BE2-DE54-FA50-E587-0E59DAFFD2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3CCFF6-3D1E-0EED-4899-5F2DC3EA0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218C13-3C9A-9673-2844-73075D6E0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2208C2-CBB8-43AF-8348-5B939522B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9288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F2B6DF-7504-A3B1-03EC-A4362B64F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F0EED6-7E5F-03C5-7BB3-42D9668D3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25C159-4A61-F31E-B780-B00B71451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CF272B-F2A3-B646-618A-4E6F2B3F5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086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FA9520-55A9-F65E-E39C-9A0090EEA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286306-1D87-2CA2-ADB7-2FCAE29F5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EE5D06-01EF-3A75-27CD-D070D6FEF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5804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D34F5-10DB-0114-0B2F-62815B4D6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02C493-673B-84FE-6C3C-75F4E24091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2958A6-4970-1183-F1A9-0E000C9EE1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C7DE8E-5237-78A5-ECD4-C24198E09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34A01C-9A1A-A966-AE9E-8AE954E5F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B3204D-305D-C0EB-9B0B-48877D107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5136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E9A61-A52C-1216-A3EB-D2FDB5C865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F429339-6B2D-E963-4EEF-AD3F81358F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12CFDE-A52C-434D-01B3-0392B073E1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583FF2-E2FF-8AB5-E1AA-A2532FE04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454484-5A24-AA2B-E234-DD222F724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848F3C-48A2-85F5-A36C-B78FA8385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1876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0E1797-8836-2A79-D19E-96A267177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05BC85-D4BB-05AF-BB4D-26AE2CAB45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6B676E-3C5E-2506-1375-1CCED71A7F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62BD92-68E5-460B-8C73-42BD0C404F58}" type="datetimeFigureOut">
              <a:rPr lang="en-CA" smtClean="0"/>
              <a:t>2025-10-2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840615-3E95-C145-BC33-1A9520873B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6FF0B9-E0D1-FD1D-169B-21D775B7FD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8A1B09-BD27-4F32-9ACE-EDACADB796D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17815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emf"/><Relationship Id="rId18" Type="http://schemas.openxmlformats.org/officeDocument/2006/relationships/image" Target="../media/image11.png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5" Type="http://schemas.openxmlformats.org/officeDocument/2006/relationships/image" Target="../media/image9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Relationship Id="rId1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image" Target="../media/image12.emf"/><Relationship Id="rId7" Type="http://schemas.openxmlformats.org/officeDocument/2006/relationships/image" Target="../media/image14.emf"/><Relationship Id="rId12" Type="http://schemas.openxmlformats.org/officeDocument/2006/relationships/image" Target="../media/image17.png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13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12" Type="http://schemas.openxmlformats.org/officeDocument/2006/relationships/oleObject" Target="../embeddings/oleObject19.bin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22.emf"/><Relationship Id="rId5" Type="http://schemas.openxmlformats.org/officeDocument/2006/relationships/image" Target="../media/image19.e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9ED0570-F277-BBC9-868D-2C082DA8A68D}"/>
              </a:ext>
            </a:extLst>
          </p:cNvPr>
          <p:cNvSpPr txBox="1"/>
          <p:nvPr/>
        </p:nvSpPr>
        <p:spPr>
          <a:xfrm>
            <a:off x="455236" y="4128238"/>
            <a:ext cx="11281528" cy="1094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, Bliss synergy scores for J1.1 cells that have been treated with either (a)MG1 and AEG 40730 or (b) MG1 and LCL 161). </a:t>
            </a:r>
            <a:r>
              <a:rPr lang="en-US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iss synergy score was calculated using </a:t>
            </a:r>
            <a:r>
              <a:rPr lang="en-US" sz="15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rgyFinder</a:t>
            </a:r>
            <a:r>
              <a:rPr lang="en-US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.0. MG1 MOI 0.001 is represented as 10, while MG1 MOI 0.0001 is represented as 1 due to the limitations of the program. Y-axis represents MG1 MOI.</a:t>
            </a:r>
            <a:endParaRPr lang="en-CA" sz="15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screen shot of a graph&#10;&#10;AI-generated content may be incorrect.">
            <a:extLst>
              <a:ext uri="{FF2B5EF4-FFF2-40B4-BE49-F238E27FC236}">
                <a16:creationId xmlns:a16="http://schemas.microsoft.com/office/drawing/2014/main" id="{5DC7E7B5-08C9-278E-CC6E-7841253DB9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2621" y="254395"/>
            <a:ext cx="3808561" cy="3733143"/>
          </a:xfrm>
          <a:prstGeom prst="rect">
            <a:avLst/>
          </a:prstGeom>
        </p:spPr>
      </p:pic>
      <p:pic>
        <p:nvPicPr>
          <p:cNvPr id="8" name="Picture 7" descr="A screen shot of a graph&#10;&#10;AI-generated content may be incorrect.">
            <a:extLst>
              <a:ext uri="{FF2B5EF4-FFF2-40B4-BE49-F238E27FC236}">
                <a16:creationId xmlns:a16="http://schemas.microsoft.com/office/drawing/2014/main" id="{846CC90C-02F2-E32B-6D26-7D6D4A89BE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260" y="250587"/>
            <a:ext cx="3727479" cy="373695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C8D29EB-35B7-9555-5FE9-3CBDC30C80E4}"/>
              </a:ext>
            </a:extLst>
          </p:cNvPr>
          <p:cNvSpPr txBox="1"/>
          <p:nvPr/>
        </p:nvSpPr>
        <p:spPr>
          <a:xfrm>
            <a:off x="575856" y="452004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88CC093-0612-3530-1368-1F8873EFF57F}"/>
              </a:ext>
            </a:extLst>
          </p:cNvPr>
          <p:cNvSpPr txBox="1"/>
          <p:nvPr/>
        </p:nvSpPr>
        <p:spPr>
          <a:xfrm>
            <a:off x="6241366" y="452004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6AAABC9-3208-D235-4C35-6796A95C0E7C}"/>
              </a:ext>
            </a:extLst>
          </p:cNvPr>
          <p:cNvSpPr/>
          <p:nvPr/>
        </p:nvSpPr>
        <p:spPr>
          <a:xfrm>
            <a:off x="6878472" y="1951630"/>
            <a:ext cx="143301" cy="2183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3037D21-8336-DDE9-BCD9-89A3BC68FFDF}"/>
              </a:ext>
            </a:extLst>
          </p:cNvPr>
          <p:cNvSpPr/>
          <p:nvPr/>
        </p:nvSpPr>
        <p:spPr>
          <a:xfrm>
            <a:off x="1303361" y="1951630"/>
            <a:ext cx="84162" cy="2183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52898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7FB4F2E-D1AD-8461-75C4-C36AD123A9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4294603"/>
              </p:ext>
            </p:extLst>
          </p:nvPr>
        </p:nvGraphicFramePr>
        <p:xfrm>
          <a:off x="420391" y="3324950"/>
          <a:ext cx="1322927" cy="138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62823" imgH="3717487" progId="Prism9.Document">
                  <p:embed/>
                </p:oleObj>
              </mc:Choice>
              <mc:Fallback>
                <p:oleObj name="Prism 9" r:id="rId2" imgW="3562823" imgH="3717487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7FB4F2E-D1AD-8461-75C4-C36AD123A9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0391" y="3324950"/>
                        <a:ext cx="1322927" cy="138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C0AE047-D235-C032-F495-63F9FD4972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2407059"/>
              </p:ext>
            </p:extLst>
          </p:nvPr>
        </p:nvGraphicFramePr>
        <p:xfrm>
          <a:off x="290463" y="185497"/>
          <a:ext cx="1615729" cy="1524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570385" imgH="3368601" progId="Prism9.Document">
                  <p:embed/>
                </p:oleObj>
              </mc:Choice>
              <mc:Fallback>
                <p:oleObj name="Prism 9" r:id="rId4" imgW="3570385" imgH="3368601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EC0AE047-D235-C032-F495-63F9FD4972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0463" y="185497"/>
                        <a:ext cx="1615729" cy="1524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D632A3F-1C98-7E0C-64AC-35DAE299ED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8585596"/>
              </p:ext>
            </p:extLst>
          </p:nvPr>
        </p:nvGraphicFramePr>
        <p:xfrm>
          <a:off x="273990" y="1761233"/>
          <a:ext cx="1599003" cy="1519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68945" imgH="3391284" progId="Prism9.Document">
                  <p:embed/>
                </p:oleObj>
              </mc:Choice>
              <mc:Fallback>
                <p:oleObj name="Prism 9" r:id="rId6" imgW="3568945" imgH="3391284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D632A3F-1C98-7E0C-64AC-35DAE299ED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3990" y="1761233"/>
                        <a:ext cx="1599003" cy="1519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Content Placeholder 3">
            <a:extLst>
              <a:ext uri="{FF2B5EF4-FFF2-40B4-BE49-F238E27FC236}">
                <a16:creationId xmlns:a16="http://schemas.microsoft.com/office/drawing/2014/main" id="{89429BE7-6D9E-035B-D56E-3154696F2255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51515113"/>
              </p:ext>
            </p:extLst>
          </p:nvPr>
        </p:nvGraphicFramePr>
        <p:xfrm>
          <a:off x="2044609" y="281021"/>
          <a:ext cx="1479199" cy="1435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598116" imgH="3493537" progId="Prism9.Document">
                  <p:embed/>
                </p:oleObj>
              </mc:Choice>
              <mc:Fallback>
                <p:oleObj name="Prism 9" r:id="rId8" imgW="3598116" imgH="3493537" progId="Prism9.Document">
                  <p:embed/>
                  <p:pic>
                    <p:nvPicPr>
                      <p:cNvPr id="10" name="Content Placeholder 3">
                        <a:extLst>
                          <a:ext uri="{FF2B5EF4-FFF2-40B4-BE49-F238E27FC236}">
                            <a16:creationId xmlns:a16="http://schemas.microsoft.com/office/drawing/2014/main" id="{89429BE7-6D9E-035B-D56E-3154696F22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44609" y="281021"/>
                        <a:ext cx="1479199" cy="1435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Content Placeholder 3">
            <a:extLst>
              <a:ext uri="{FF2B5EF4-FFF2-40B4-BE49-F238E27FC236}">
                <a16:creationId xmlns:a16="http://schemas.microsoft.com/office/drawing/2014/main" id="{25B0C624-DA04-42EC-D47C-C9758D2881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1911978"/>
              </p:ext>
            </p:extLst>
          </p:nvPr>
        </p:nvGraphicFramePr>
        <p:xfrm>
          <a:off x="2074896" y="1900156"/>
          <a:ext cx="1418625" cy="138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608560" imgH="3508659" progId="Prism9.Document">
                  <p:embed/>
                </p:oleObj>
              </mc:Choice>
              <mc:Fallback>
                <p:oleObj name="Prism 9" r:id="rId10" imgW="3608560" imgH="3508659" progId="Prism9.Document">
                  <p:embed/>
                  <p:pic>
                    <p:nvPicPr>
                      <p:cNvPr id="11" name="Content Placeholder 3">
                        <a:extLst>
                          <a:ext uri="{FF2B5EF4-FFF2-40B4-BE49-F238E27FC236}">
                            <a16:creationId xmlns:a16="http://schemas.microsoft.com/office/drawing/2014/main" id="{25B0C624-DA04-42EC-D47C-C9758D2881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074896" y="1900156"/>
                        <a:ext cx="1418625" cy="138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AFEF5D8A-3EF5-C85D-A472-B6873B485B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1051977"/>
              </p:ext>
            </p:extLst>
          </p:nvPr>
        </p:nvGraphicFramePr>
        <p:xfrm>
          <a:off x="2044609" y="3371216"/>
          <a:ext cx="1479199" cy="1355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791509" imgH="3476615" progId="Prism9.Document">
                  <p:embed/>
                </p:oleObj>
              </mc:Choice>
              <mc:Fallback>
                <p:oleObj name="Prism 9" r:id="rId12" imgW="3791509" imgH="3476615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AFEF5D8A-3EF5-C85D-A472-B6873B485B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044609" y="3371216"/>
                        <a:ext cx="1479199" cy="1355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46D6035-A79E-CFCD-2BE1-6D12D8563F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9661752"/>
              </p:ext>
            </p:extLst>
          </p:nvPr>
        </p:nvGraphicFramePr>
        <p:xfrm>
          <a:off x="3695423" y="1821917"/>
          <a:ext cx="1195696" cy="15648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665004" imgH="3490297" progId="Prism9.Document">
                  <p:embed/>
                </p:oleObj>
              </mc:Choice>
              <mc:Fallback>
                <p:oleObj name="Prism 9" r:id="rId14" imgW="2665004" imgH="3490297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C46D6035-A79E-CFCD-2BE1-6D12D8563F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695423" y="1821917"/>
                        <a:ext cx="1195696" cy="15648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5E09BD92-B80A-BB55-F6BC-F13C8542D2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0561236"/>
              </p:ext>
            </p:extLst>
          </p:nvPr>
        </p:nvGraphicFramePr>
        <p:xfrm>
          <a:off x="3662225" y="70980"/>
          <a:ext cx="1200946" cy="16458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678689" imgH="3670321" progId="Prism9.Document">
                  <p:embed/>
                </p:oleObj>
              </mc:Choice>
              <mc:Fallback>
                <p:oleObj name="Prism 9" r:id="rId16" imgW="2678689" imgH="3670321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5E09BD92-B80A-BB55-F6BC-F13C8542D2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662225" y="70980"/>
                        <a:ext cx="1200946" cy="16458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3A556E06-485A-C8A0-4EFF-49F7ABD04B36}"/>
              </a:ext>
            </a:extLst>
          </p:cNvPr>
          <p:cNvSpPr txBox="1"/>
          <p:nvPr/>
        </p:nvSpPr>
        <p:spPr>
          <a:xfrm>
            <a:off x="129803" y="4651895"/>
            <a:ext cx="11932394" cy="18607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526"/>
              </a:spcAft>
            </a:pPr>
            <a:r>
              <a:rPr lang="en-CA" sz="1300" b="1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, SMAC mimetics synergize with the OV MG1 to kill OM10.1 cells only when OM10.1 cells are pre-treated with AEG 40730.  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10.1 cells were infected with MG1 MOI range 1x10</a:t>
            </a:r>
            <a:r>
              <a:rPr lang="en-CA" sz="1300" kern="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2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 1x10</a:t>
            </a:r>
            <a:r>
              <a:rPr lang="en-CA" sz="1300" kern="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treated with SMAC mimetics AEG 40730 (2 µM, and 6 µM.), LCL 161 (10 µM and   20 µM) and birinapant (2 µM). Cell death was measured by flow cytometry via PI staining. </a:t>
            </a:r>
            <a:r>
              <a:rPr lang="en-CA" sz="13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viability of OM10.1 cells following 48hpi concurrent treatment.</a:t>
            </a:r>
            <a:r>
              <a:rPr lang="en-CA" sz="13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) 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viability of OM10.1 cells 48hpi that were infected with MG1 first and treated with SMAC mimetics 24h after  and</a:t>
            </a:r>
            <a:r>
              <a:rPr lang="en-CA" sz="13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) 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viability of OM10.1 cells 24hpi that were pre-treated with SMAC mimetics and then infected with MG1 24h after.  (**</a:t>
            </a:r>
            <a:r>
              <a:rPr lang="en-CA" sz="13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.01, ****</a:t>
            </a:r>
            <a:r>
              <a:rPr lang="en-CA" sz="13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.0001, by 2-way analysis of variance with the </a:t>
            </a:r>
            <a:r>
              <a:rPr lang="en-CA" sz="1300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nnet</a:t>
            </a:r>
            <a:r>
              <a:rPr lang="en-CA" sz="13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st hoc test for multiple comparisons between different SMAC mimetic doses. Data represent mean values ± standard deviation of the mean; n values represent separate biological replicates.)</a:t>
            </a:r>
            <a:endParaRPr lang="en-CA" sz="13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E438D22-5B18-EA48-417A-C93FB1D68C43}"/>
              </a:ext>
            </a:extLst>
          </p:cNvPr>
          <p:cNvCxnSpPr>
            <a:cxnSpLocks/>
          </p:cNvCxnSpPr>
          <p:nvPr/>
        </p:nvCxnSpPr>
        <p:spPr>
          <a:xfrm>
            <a:off x="454010" y="1761232"/>
            <a:ext cx="438356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2CDDDA7-55FC-C40C-5E5D-77B4E9CD7925}"/>
              </a:ext>
            </a:extLst>
          </p:cNvPr>
          <p:cNvCxnSpPr>
            <a:cxnSpLocks/>
          </p:cNvCxnSpPr>
          <p:nvPr/>
        </p:nvCxnSpPr>
        <p:spPr>
          <a:xfrm>
            <a:off x="507556" y="3280570"/>
            <a:ext cx="315466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" name="Picture 19" descr="A group of blue and purple squares&#10;&#10;Description automatically generated with medium confidence">
            <a:extLst>
              <a:ext uri="{FF2B5EF4-FFF2-40B4-BE49-F238E27FC236}">
                <a16:creationId xmlns:a16="http://schemas.microsoft.com/office/drawing/2014/main" id="{E71FDBD2-D2C1-DFFA-56D4-9134EC8DBC48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0758" y="3617863"/>
            <a:ext cx="950361" cy="73104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721D1621-2402-8706-C99E-9773646DDDF8}"/>
              </a:ext>
            </a:extLst>
          </p:cNvPr>
          <p:cNvSpPr txBox="1"/>
          <p:nvPr/>
        </p:nvSpPr>
        <p:spPr>
          <a:xfrm>
            <a:off x="179922" y="174263"/>
            <a:ext cx="41703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47AB431-7332-BE09-F25C-7D2D88C05060}"/>
              </a:ext>
            </a:extLst>
          </p:cNvPr>
          <p:cNvSpPr txBox="1"/>
          <p:nvPr/>
        </p:nvSpPr>
        <p:spPr>
          <a:xfrm>
            <a:off x="191947" y="1819830"/>
            <a:ext cx="41703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499FF1F-0A0F-C476-6D66-91595A052137}"/>
              </a:ext>
            </a:extLst>
          </p:cNvPr>
          <p:cNvSpPr txBox="1"/>
          <p:nvPr/>
        </p:nvSpPr>
        <p:spPr>
          <a:xfrm>
            <a:off x="245492" y="3371216"/>
            <a:ext cx="41703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8267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3">
            <a:extLst>
              <a:ext uri="{FF2B5EF4-FFF2-40B4-BE49-F238E27FC236}">
                <a16:creationId xmlns:a16="http://schemas.microsoft.com/office/drawing/2014/main" id="{B341EBFA-D5C9-B287-54F1-B2452DAFD210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35501328"/>
              </p:ext>
            </p:extLst>
          </p:nvPr>
        </p:nvGraphicFramePr>
        <p:xfrm>
          <a:off x="6439958" y="1178158"/>
          <a:ext cx="1901423" cy="18518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68945" imgH="3476615" progId="Prism9.Document">
                  <p:embed/>
                </p:oleObj>
              </mc:Choice>
              <mc:Fallback>
                <p:oleObj name="Prism 9" r:id="rId2" imgW="3568945" imgH="3476615" progId="Prism9.Document">
                  <p:embed/>
                  <p:pic>
                    <p:nvPicPr>
                      <p:cNvPr id="5" name="Content Placeholder 3">
                        <a:extLst>
                          <a:ext uri="{FF2B5EF4-FFF2-40B4-BE49-F238E27FC236}">
                            <a16:creationId xmlns:a16="http://schemas.microsoft.com/office/drawing/2014/main" id="{B341EBFA-D5C9-B287-54F1-B2452DAFD2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39958" y="1178158"/>
                        <a:ext cx="1901423" cy="18518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FD9EC50-7B5F-3588-D3D2-489E71B4EF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9589140"/>
              </p:ext>
            </p:extLst>
          </p:nvPr>
        </p:nvGraphicFramePr>
        <p:xfrm>
          <a:off x="561411" y="861356"/>
          <a:ext cx="2048361" cy="21053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568945" imgH="3670321" progId="Prism9.Document">
                  <p:embed/>
                </p:oleObj>
              </mc:Choice>
              <mc:Fallback>
                <p:oleObj name="Prism 9" r:id="rId4" imgW="3568945" imgH="3670321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FD9EC50-7B5F-3588-D3D2-489E71B4EF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1411" y="861356"/>
                        <a:ext cx="2048361" cy="21053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82BDD3D-2A33-D3CA-6393-80AB389C2C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138798"/>
              </p:ext>
            </p:extLst>
          </p:nvPr>
        </p:nvGraphicFramePr>
        <p:xfrm>
          <a:off x="2244523" y="1073973"/>
          <a:ext cx="1996614" cy="1944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596315" imgH="3499658" progId="Prism9.Document">
                  <p:embed/>
                </p:oleObj>
              </mc:Choice>
              <mc:Fallback>
                <p:oleObj name="Prism 9" r:id="rId6" imgW="3596315" imgH="3499658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82BDD3D-2A33-D3CA-6393-80AB389C2C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44523" y="1073973"/>
                        <a:ext cx="1996614" cy="19440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584077C7-A0C7-EE66-43C8-BE5B9A5DB6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8725554"/>
              </p:ext>
            </p:extLst>
          </p:nvPr>
        </p:nvGraphicFramePr>
        <p:xfrm>
          <a:off x="8341381" y="1114875"/>
          <a:ext cx="1779323" cy="18759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611801" imgH="3810379" progId="Prism9.Document">
                  <p:embed/>
                </p:oleObj>
              </mc:Choice>
              <mc:Fallback>
                <p:oleObj name="Prism 9" r:id="rId8" imgW="3611801" imgH="3810379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584077C7-A0C7-EE66-43C8-BE5B9A5DB6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341381" y="1114875"/>
                        <a:ext cx="1779323" cy="18759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82CFE7A4-5F23-6AB6-EC11-1C611BF6EC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807430"/>
              </p:ext>
            </p:extLst>
          </p:nvPr>
        </p:nvGraphicFramePr>
        <p:xfrm>
          <a:off x="3886606" y="1046185"/>
          <a:ext cx="1558678" cy="1990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678689" imgH="3423328" progId="Prism9.Document">
                  <p:embed/>
                </p:oleObj>
              </mc:Choice>
              <mc:Fallback>
                <p:oleObj name="Prism 9" r:id="rId10" imgW="2678689" imgH="3423328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82CFE7A4-5F23-6AB6-EC11-1C611BF6EC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886606" y="1046185"/>
                        <a:ext cx="1558678" cy="1990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512DF75C-D217-ED67-F2C3-421907E92A63}"/>
              </a:ext>
            </a:extLst>
          </p:cNvPr>
          <p:cNvSpPr txBox="1"/>
          <p:nvPr/>
        </p:nvSpPr>
        <p:spPr>
          <a:xfrm>
            <a:off x="593889" y="4099719"/>
            <a:ext cx="10699422" cy="2893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526"/>
              </a:spcAft>
            </a:pP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, cell viability of J1.1 cells after combination treatment with MG1 and SMAC mimetics 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1.1 cells were infected with MG1 MOI range 1x10</a:t>
            </a:r>
            <a:r>
              <a:rPr lang="en-CA" sz="1500" kern="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3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 1x10</a:t>
            </a:r>
            <a:r>
              <a:rPr lang="en-CA" sz="1500" kern="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4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treated with SMAC mimetics AEG 40730 (2 µM, and 4 µM.), LCL 161 (2 µM and   10 µM) and birinapant (1 µM). Cell death was measured by flow cytometry via PI staining .</a:t>
            </a: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)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viability of J1.1 cells at 48hpi that were infected with MG1 first and treated with SMAC mimetics 24h after  and </a:t>
            </a: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viability of J1.1 cells 24hpi that were pre-treated with SMAC mimetics and then infected with MG1 24h after.  (**</a:t>
            </a:r>
            <a:r>
              <a:rPr lang="en-CA" sz="15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&lt; .01, ***</a:t>
            </a:r>
            <a:r>
              <a:rPr lang="en-CA" sz="15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.001, ****</a:t>
            </a:r>
            <a:r>
              <a:rPr lang="en-CA" sz="15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.0001, by 2-way analysis of variance with the </a:t>
            </a:r>
            <a:r>
              <a:rPr lang="en-CA" sz="1500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nnet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st hoc test for multiple comparisons between different SMAC mimetic doses. Data represent mean values ± standard deviation of the mean; n values represent separate biological replicates.)</a:t>
            </a:r>
          </a:p>
          <a:p>
            <a:pPr>
              <a:lnSpc>
                <a:spcPct val="150000"/>
              </a:lnSpc>
            </a:pP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Picture 27" descr="A group of blue and purple rectangular boxes with black text&#10;&#10;Description automatically generated">
            <a:extLst>
              <a:ext uri="{FF2B5EF4-FFF2-40B4-BE49-F238E27FC236}">
                <a16:creationId xmlns:a16="http://schemas.microsoft.com/office/drawing/2014/main" id="{C0B4CCD2-7D3C-7727-2EBD-3EA90631E4A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93682" y="981674"/>
            <a:ext cx="1394435" cy="932032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67BC0551-DBF7-94A5-F25F-223DF68049F9}"/>
              </a:ext>
            </a:extLst>
          </p:cNvPr>
          <p:cNvSpPr txBox="1"/>
          <p:nvPr/>
        </p:nvSpPr>
        <p:spPr>
          <a:xfrm>
            <a:off x="6351729" y="1056843"/>
            <a:ext cx="49057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AEA0C28-8F20-7840-3ADF-C325CFFA4F08}"/>
              </a:ext>
            </a:extLst>
          </p:cNvPr>
          <p:cNvSpPr txBox="1"/>
          <p:nvPr/>
        </p:nvSpPr>
        <p:spPr>
          <a:xfrm>
            <a:off x="377073" y="1073973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53447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C049986-3998-F57A-45BB-248186B13E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9876294"/>
              </p:ext>
            </p:extLst>
          </p:nvPr>
        </p:nvGraphicFramePr>
        <p:xfrm>
          <a:off x="0" y="1009116"/>
          <a:ext cx="2106320" cy="24808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974361" imgH="3503979" progId="Prism9.Document">
                  <p:embed/>
                </p:oleObj>
              </mc:Choice>
              <mc:Fallback>
                <p:oleObj name="Prism 9" r:id="rId2" imgW="2974361" imgH="3503979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C049986-3998-F57A-45BB-248186B13E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009116"/>
                        <a:ext cx="2106320" cy="24808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FEAB143-38F7-2410-869A-B32D8C2A28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9105725"/>
              </p:ext>
            </p:extLst>
          </p:nvPr>
        </p:nvGraphicFramePr>
        <p:xfrm>
          <a:off x="1789113" y="923925"/>
          <a:ext cx="2246312" cy="264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972920" imgH="3511900" progId="Prism9.Document">
                  <p:embed/>
                </p:oleObj>
              </mc:Choice>
              <mc:Fallback>
                <p:oleObj name="Prism 9" r:id="rId4" imgW="2972920" imgH="3511900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DFEAB143-38F7-2410-869A-B32D8C2A28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89113" y="923925"/>
                        <a:ext cx="2246312" cy="2649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1F20DCA-4FCC-AFF5-39FF-21208CCDD7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613935"/>
              </p:ext>
            </p:extLst>
          </p:nvPr>
        </p:nvGraphicFramePr>
        <p:xfrm>
          <a:off x="3708553" y="940520"/>
          <a:ext cx="2750132" cy="25798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753334" imgH="3520901" progId="Prism9.Document">
                  <p:embed/>
                </p:oleObj>
              </mc:Choice>
              <mc:Fallback>
                <p:oleObj name="Prism 9" r:id="rId6" imgW="3753334" imgH="3520901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1F20DCA-4FCC-AFF5-39FF-21208CCDD7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08553" y="940520"/>
                        <a:ext cx="2750132" cy="25798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D23D0A1-38EF-23C1-984D-834506B354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2100829"/>
              </p:ext>
            </p:extLst>
          </p:nvPr>
        </p:nvGraphicFramePr>
        <p:xfrm>
          <a:off x="9868744" y="676844"/>
          <a:ext cx="2099326" cy="27521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271736" imgH="2978310" progId="Prism9.Document">
                  <p:embed/>
                </p:oleObj>
              </mc:Choice>
              <mc:Fallback>
                <p:oleObj name="Prism 9" r:id="rId8" imgW="2271736" imgH="2978310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D23D0A1-38EF-23C1-984D-834506B354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868744" y="676844"/>
                        <a:ext cx="2099326" cy="27521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46CB866-9E0A-640A-246F-2F95913783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3530451"/>
              </p:ext>
            </p:extLst>
          </p:nvPr>
        </p:nvGraphicFramePr>
        <p:xfrm>
          <a:off x="8417066" y="759457"/>
          <a:ext cx="2099326" cy="2760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271736" imgH="2987311" progId="Prism9.Document">
                  <p:embed/>
                </p:oleObj>
              </mc:Choice>
              <mc:Fallback>
                <p:oleObj name="Prism 9" r:id="rId10" imgW="2271736" imgH="2987311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D46CB866-9E0A-640A-246F-2F95913783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417066" y="759457"/>
                        <a:ext cx="2099326" cy="2760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A53A52A1-1228-EF33-A43C-93EA6488B7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6165832"/>
              </p:ext>
            </p:extLst>
          </p:nvPr>
        </p:nvGraphicFramePr>
        <p:xfrm>
          <a:off x="6895596" y="759457"/>
          <a:ext cx="2099326" cy="27800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271736" imgH="3008914" progId="Prism9.Document">
                  <p:embed/>
                </p:oleObj>
              </mc:Choice>
              <mc:Fallback>
                <p:oleObj name="Prism 9" r:id="rId12" imgW="2271736" imgH="3008914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A53A52A1-1228-EF33-A43C-93EA6488B7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895596" y="759457"/>
                        <a:ext cx="2099326" cy="27800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DEDE7150-89CB-DC33-4193-B79D3318B371}"/>
              </a:ext>
            </a:extLst>
          </p:cNvPr>
          <p:cNvSpPr txBox="1"/>
          <p:nvPr/>
        </p:nvSpPr>
        <p:spPr>
          <a:xfrm>
            <a:off x="223930" y="649890"/>
            <a:ext cx="567832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896E74-B2E9-25CA-51A6-AD5BDFB12E9E}"/>
              </a:ext>
            </a:extLst>
          </p:cNvPr>
          <p:cNvSpPr txBox="1"/>
          <p:nvPr/>
        </p:nvSpPr>
        <p:spPr>
          <a:xfrm>
            <a:off x="6394281" y="898009"/>
            <a:ext cx="592769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03959E6-C7BB-565C-8748-7D25FA673463}"/>
              </a:ext>
            </a:extLst>
          </p:cNvPr>
          <p:cNvSpPr txBox="1"/>
          <p:nvPr/>
        </p:nvSpPr>
        <p:spPr>
          <a:xfrm>
            <a:off x="367644" y="4378923"/>
            <a:ext cx="11896627" cy="17865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526"/>
              </a:spcAft>
            </a:pP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, Cell viability of OM10.1 cells after combination treatment with VSV</a:t>
            </a:r>
            <a:r>
              <a:rPr lang="el-GR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1</a:t>
            </a: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SMAC mimetics 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10.1 cells were infected with VSV</a:t>
            </a:r>
            <a:r>
              <a:rPr lang="el-GR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1 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I 1 and treated with SMAC mimetics AEG 40730 (6 µM.), LCL 161 (20 µM) and birinapant (2 µM). Cell death was measured by flow cytometry via PI staining. </a:t>
            </a: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w A)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viability of OM10.1 cells following 48hpi concurrent treatment </a:t>
            </a:r>
            <a:r>
              <a:rPr lang="en-CA" sz="15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w B)  </a:t>
            </a:r>
            <a:r>
              <a:rPr lang="en-CA" sz="15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FP% following 48h of concurrent treatment. Data analysis by 2-way analysis of variance with the Dunnet post hoc test for multiple comparisons between different SMAC mimetic doses. Data represent mean values ± standard deviation of the mean; n values represent separate biological replicates.)</a:t>
            </a:r>
          </a:p>
        </p:txBody>
      </p:sp>
    </p:spTree>
    <p:extLst>
      <p:ext uri="{BB962C8B-B14F-4D97-AF65-F5344CB8AC3E}">
        <p14:creationId xmlns:p14="http://schemas.microsoft.com/office/powerpoint/2010/main" val="60324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FD6D44B-B9DB-444F-6924-7884ECC8B33A}"/>
              </a:ext>
            </a:extLst>
          </p:cNvPr>
          <p:cNvSpPr txBox="1"/>
          <p:nvPr/>
        </p:nvSpPr>
        <p:spPr>
          <a:xfrm>
            <a:off x="455236" y="4128238"/>
            <a:ext cx="11281528" cy="2132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500" b="1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5, </a:t>
            </a:r>
            <a:r>
              <a:rPr lang="en-US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ole of TNF</a:t>
            </a:r>
            <a:r>
              <a:rPr lang="el-GR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FN</a:t>
            </a:r>
            <a:r>
              <a:rPr lang="el-GR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5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HIV infected MDM treated with oncolytic viruses and SMAC mimetics remains elusive. </a:t>
            </a:r>
            <a:r>
              <a:rPr lang="en-CA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HIV infected MDM were infected with MG1 or VSV</a:t>
            </a:r>
            <a:r>
              <a:rPr lang="el-GR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1 at </a:t>
            </a:r>
            <a:r>
              <a:rPr lang="en-CA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I 1 and treated with the SMAC mimetic LCL 161 (4 µM) or birinapant (2 µM). TNF</a:t>
            </a:r>
            <a:r>
              <a:rPr lang="el-GR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s measured 48h post treatment via </a:t>
            </a:r>
            <a:r>
              <a:rPr lang="en-CA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NFα ELISA. B) HIV infected MDM were either left untreated, treated with 2µM birinapant, treated with 10 µg TNFα, or treated with a combination of birinapant and TNFα. Cell death was measured 48h post treatment via </a:t>
            </a:r>
            <a:r>
              <a:rPr lang="en-CA" sz="15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nexinV</a:t>
            </a:r>
            <a:r>
              <a:rPr lang="en-CA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in bulk macrophage population by flow cytometry.  C) HIV infected MDM were infected with VSVΔ51 MOI 1 and treated with the SMAC mimetic LCL 161 (4 µM) or birinapant (2 µM). IFN</a:t>
            </a:r>
            <a:r>
              <a:rPr lang="el-GR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s measured 48h post treatment via </a:t>
            </a:r>
            <a:r>
              <a:rPr lang="en-CA" sz="15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FNα ELISA.</a:t>
            </a:r>
            <a:endParaRPr lang="en-CA" sz="15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FFDC9960-2519-C2AF-909A-73DDE7653F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5252" y="633441"/>
            <a:ext cx="2344611" cy="2705526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1AE93D1-CEB8-FE4A-CB39-BB74599ED0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7878858"/>
              </p:ext>
            </p:extLst>
          </p:nvPr>
        </p:nvGraphicFramePr>
        <p:xfrm>
          <a:off x="4378076" y="685988"/>
          <a:ext cx="2598490" cy="2812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195484" imgH="3458253" progId="Prism9.Document">
                  <p:embed/>
                </p:oleObj>
              </mc:Choice>
              <mc:Fallback>
                <p:oleObj name="Prism 9" r:id="rId3" imgW="3195484" imgH="3458253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1AE93D1-CEB8-FE4A-CB39-BB74599ED0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78076" y="685988"/>
                        <a:ext cx="2598490" cy="28122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2FCCF5A-031C-8356-2F21-296E47FB82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8659422"/>
              </p:ext>
            </p:extLst>
          </p:nvPr>
        </p:nvGraphicFramePr>
        <p:xfrm>
          <a:off x="311873" y="763346"/>
          <a:ext cx="3326255" cy="28376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663661" imgH="3126289" progId="Prism9.Document">
                  <p:embed/>
                </p:oleObj>
              </mc:Choice>
              <mc:Fallback>
                <p:oleObj name="Prism 9" r:id="rId5" imgW="3663661" imgH="3126289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A2FCCF5A-031C-8356-2F21-296E47FB82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1873" y="763346"/>
                        <a:ext cx="3326255" cy="28376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F9673542-4246-B172-5745-3011AF18EF58}"/>
              </a:ext>
            </a:extLst>
          </p:cNvPr>
          <p:cNvSpPr txBox="1"/>
          <p:nvPr/>
        </p:nvSpPr>
        <p:spPr>
          <a:xfrm>
            <a:off x="132797" y="1055320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5D7A75-DCD8-57EF-92F0-8DD2DACFF6A4}"/>
              </a:ext>
            </a:extLst>
          </p:cNvPr>
          <p:cNvSpPr txBox="1"/>
          <p:nvPr/>
        </p:nvSpPr>
        <p:spPr>
          <a:xfrm>
            <a:off x="3896362" y="870654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91BF1E8-4B54-30B0-DE2E-27C9B2948645}"/>
              </a:ext>
            </a:extLst>
          </p:cNvPr>
          <p:cNvSpPr txBox="1"/>
          <p:nvPr/>
        </p:nvSpPr>
        <p:spPr>
          <a:xfrm>
            <a:off x="7191943" y="918199"/>
            <a:ext cx="358154" cy="274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CA" sz="118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7297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8</TotalTime>
  <Words>719</Words>
  <Application>Microsoft Office PowerPoint</Application>
  <PresentationFormat>Widescreen</PresentationFormat>
  <Paragraphs>18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gisu Molyer</dc:creator>
  <cp:lastModifiedBy>Bengisu Molyer</cp:lastModifiedBy>
  <cp:revision>16</cp:revision>
  <dcterms:created xsi:type="dcterms:W3CDTF">2024-11-06T17:37:31Z</dcterms:created>
  <dcterms:modified xsi:type="dcterms:W3CDTF">2025-10-28T23:39:44Z</dcterms:modified>
</cp:coreProperties>
</file>